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70" r:id="rId2"/>
    <p:sldId id="271" r:id="rId3"/>
    <p:sldId id="257" r:id="rId4"/>
    <p:sldId id="269" r:id="rId5"/>
    <p:sldId id="258" r:id="rId6"/>
    <p:sldId id="259" r:id="rId7"/>
    <p:sldId id="260" r:id="rId8"/>
    <p:sldId id="268" r:id="rId9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1224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mir19'!$F$65</c:f>
              <c:strCache>
                <c:ptCount val="1"/>
                <c:pt idx="0">
                  <c:v>hsa-miR-19A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E42-431A-A014-6F005288045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E42-431A-A014-6F005288045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E42-431A-A014-6F0052880455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E42-431A-A014-6F0052880455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E42-431A-A014-6F0052880455}"/>
              </c:ext>
            </c:extLst>
          </c:dPt>
          <c:cat>
            <c:strRef>
              <c:f>'mir19'!$G$64:$T$64</c:f>
              <c:strCache>
                <c:ptCount val="14"/>
                <c:pt idx="0">
                  <c:v>HD</c:v>
                </c:pt>
                <c:pt idx="1">
                  <c:v>ICU</c:v>
                </c:pt>
                <c:pt idx="2">
                  <c:v>pt50</c:v>
                </c:pt>
                <c:pt idx="3">
                  <c:v>pt7_4</c:v>
                </c:pt>
                <c:pt idx="5">
                  <c:v>pt68</c:v>
                </c:pt>
                <c:pt idx="6">
                  <c:v>pt67_2</c:v>
                </c:pt>
                <c:pt idx="7">
                  <c:v>pt67_1</c:v>
                </c:pt>
                <c:pt idx="9">
                  <c:v>pt44</c:v>
                </c:pt>
                <c:pt idx="10">
                  <c:v>pt25</c:v>
                </c:pt>
                <c:pt idx="11">
                  <c:v>pt7</c:v>
                </c:pt>
                <c:pt idx="12">
                  <c:v>pt5</c:v>
                </c:pt>
                <c:pt idx="13">
                  <c:v>pt1</c:v>
                </c:pt>
              </c:strCache>
            </c:strRef>
          </c:cat>
          <c:val>
            <c:numRef>
              <c:f>'mir19'!$G$65:$T$65</c:f>
              <c:numCache>
                <c:formatCode>General</c:formatCode>
                <c:ptCount val="14"/>
                <c:pt idx="0">
                  <c:v>12.5219681283013</c:v>
                </c:pt>
                <c:pt idx="1">
                  <c:v>0</c:v>
                </c:pt>
                <c:pt idx="2">
                  <c:v>3.7531268415059</c:v>
                </c:pt>
                <c:pt idx="3">
                  <c:v>1.4344031772099299</c:v>
                </c:pt>
                <c:pt idx="5">
                  <c:v>0</c:v>
                </c:pt>
                <c:pt idx="6">
                  <c:v>1.3474129521982401</c:v>
                </c:pt>
                <c:pt idx="7">
                  <c:v>2.1680304860141399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197689748492926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E42-431A-A014-6F00528804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80214600"/>
        <c:axId val="480216240"/>
      </c:barChart>
      <c:catAx>
        <c:axId val="48021460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80216240"/>
        <c:crossesAt val="1.0000000000000002E-2"/>
        <c:auto val="1"/>
        <c:lblAlgn val="ctr"/>
        <c:lblOffset val="100"/>
        <c:noMultiLvlLbl val="0"/>
      </c:catAx>
      <c:valAx>
        <c:axId val="480216240"/>
        <c:scaling>
          <c:logBase val="10"/>
          <c:orientation val="minMax"/>
          <c:min val="1.0000000000000002E-2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80214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C2F-4626-B8EC-ABE4C6B3B21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C2F-4626-B8EC-ABE4C6B3B21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C2F-4626-B8EC-ABE4C6B3B214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C2F-4626-B8EC-ABE4C6B3B21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4C2F-4626-B8EC-ABE4C6B3B214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4C2F-4626-B8EC-ABE4C6B3B214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4C2F-4626-B8EC-ABE4C6B3B214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4C2F-4626-B8EC-ABE4C6B3B214}"/>
              </c:ext>
            </c:extLst>
          </c:dPt>
          <c:cat>
            <c:strRef>
              <c:f>'let7'!$L$20:$Z$20</c:f>
              <c:strCache>
                <c:ptCount val="15"/>
                <c:pt idx="0">
                  <c:v>HD</c:v>
                </c:pt>
                <c:pt idx="1">
                  <c:v>ICU</c:v>
                </c:pt>
                <c:pt idx="3">
                  <c:v>pt50</c:v>
                </c:pt>
                <c:pt idx="4">
                  <c:v>pt7_4</c:v>
                </c:pt>
                <c:pt idx="6">
                  <c:v>pt68</c:v>
                </c:pt>
                <c:pt idx="7">
                  <c:v>pt67_2</c:v>
                </c:pt>
                <c:pt idx="8">
                  <c:v>pt67_1</c:v>
                </c:pt>
                <c:pt idx="10">
                  <c:v>pt44</c:v>
                </c:pt>
                <c:pt idx="11">
                  <c:v>pt25</c:v>
                </c:pt>
                <c:pt idx="12">
                  <c:v>pt7</c:v>
                </c:pt>
                <c:pt idx="13">
                  <c:v>pt5</c:v>
                </c:pt>
                <c:pt idx="14">
                  <c:v>pt1</c:v>
                </c:pt>
              </c:strCache>
            </c:strRef>
          </c:cat>
          <c:val>
            <c:numRef>
              <c:f>'let7'!$L$21:$Z$21</c:f>
              <c:numCache>
                <c:formatCode>General</c:formatCode>
                <c:ptCount val="15"/>
                <c:pt idx="0">
                  <c:v>2297.08548664727</c:v>
                </c:pt>
                <c:pt idx="1">
                  <c:v>3.3762911766291199</c:v>
                </c:pt>
                <c:pt idx="3">
                  <c:v>0</c:v>
                </c:pt>
                <c:pt idx="4">
                  <c:v>23.9067196201655</c:v>
                </c:pt>
                <c:pt idx="6">
                  <c:v>25.166141868156998</c:v>
                </c:pt>
                <c:pt idx="7">
                  <c:v>46.822600088888898</c:v>
                </c:pt>
                <c:pt idx="8">
                  <c:v>4.3360609720282799</c:v>
                </c:pt>
                <c:pt idx="10">
                  <c:v>0</c:v>
                </c:pt>
                <c:pt idx="11">
                  <c:v>4.00117607891357</c:v>
                </c:pt>
                <c:pt idx="12">
                  <c:v>5.7317449224598498</c:v>
                </c:pt>
                <c:pt idx="13">
                  <c:v>4.7445539638302403</c:v>
                </c:pt>
                <c:pt idx="14">
                  <c:v>3.1010976879379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C2F-4626-B8EC-ABE4C6B3B2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691559344"/>
        <c:axId val="691559672"/>
      </c:barChart>
      <c:catAx>
        <c:axId val="6915593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91559672"/>
        <c:crosses val="autoZero"/>
        <c:auto val="1"/>
        <c:lblAlgn val="ctr"/>
        <c:lblOffset val="100"/>
        <c:noMultiLvlLbl val="0"/>
      </c:catAx>
      <c:valAx>
        <c:axId val="691559672"/>
        <c:scaling>
          <c:logBase val="10"/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91559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20603674540684"/>
          <c:y val="2.7777777777777776E-2"/>
          <c:w val="0.84357174103237098"/>
          <c:h val="0.8416746864975212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7C4-4D2C-B70A-AF816545B5B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7C4-4D2C-B70A-AF816545B5B4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7C4-4D2C-B70A-AF816545B5B4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7C4-4D2C-B70A-AF816545B5B4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07C4-4D2C-B70A-AF816545B5B4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07C4-4D2C-B70A-AF816545B5B4}"/>
              </c:ext>
            </c:extLst>
          </c:dPt>
          <c:cat>
            <c:strRef>
              <c:f>mir23b!$E$15:$S$15</c:f>
              <c:strCache>
                <c:ptCount val="15"/>
                <c:pt idx="0">
                  <c:v>HD</c:v>
                </c:pt>
                <c:pt idx="1">
                  <c:v>ICU</c:v>
                </c:pt>
                <c:pt idx="3">
                  <c:v>pt50</c:v>
                </c:pt>
                <c:pt idx="4">
                  <c:v>pt7_4</c:v>
                </c:pt>
                <c:pt idx="6">
                  <c:v>pt68</c:v>
                </c:pt>
                <c:pt idx="7">
                  <c:v>pt67_2</c:v>
                </c:pt>
                <c:pt idx="8">
                  <c:v>pt67_1</c:v>
                </c:pt>
                <c:pt idx="10">
                  <c:v>pt44</c:v>
                </c:pt>
                <c:pt idx="11">
                  <c:v>pt25</c:v>
                </c:pt>
                <c:pt idx="12">
                  <c:v>pt7</c:v>
                </c:pt>
                <c:pt idx="13">
                  <c:v>pt5</c:v>
                </c:pt>
                <c:pt idx="14">
                  <c:v>pt1</c:v>
                </c:pt>
              </c:strCache>
            </c:strRef>
          </c:cat>
          <c:val>
            <c:numRef>
              <c:f>mir23b!$E$16:$S$16</c:f>
              <c:numCache>
                <c:formatCode>General</c:formatCode>
                <c:ptCount val="15"/>
                <c:pt idx="0">
                  <c:v>5.56531916813391</c:v>
                </c:pt>
                <c:pt idx="1">
                  <c:v>1.5005738562796</c:v>
                </c:pt>
                <c:pt idx="3">
                  <c:v>0</c:v>
                </c:pt>
                <c:pt idx="4">
                  <c:v>4.3032095316297898</c:v>
                </c:pt>
                <c:pt idx="6">
                  <c:v>6.2915354670392603</c:v>
                </c:pt>
                <c:pt idx="7">
                  <c:v>7.7476244751398902</c:v>
                </c:pt>
                <c:pt idx="8">
                  <c:v>10.840152430070599</c:v>
                </c:pt>
                <c:pt idx="10">
                  <c:v>0</c:v>
                </c:pt>
                <c:pt idx="11">
                  <c:v>2.0005880394567801</c:v>
                </c:pt>
                <c:pt idx="12">
                  <c:v>3.1264063213417299</c:v>
                </c:pt>
                <c:pt idx="13">
                  <c:v>2.5699667304080398</c:v>
                </c:pt>
                <c:pt idx="14">
                  <c:v>6.2021953758758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7C4-4D2C-B70A-AF816545B5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691532448"/>
        <c:axId val="691531464"/>
      </c:barChart>
      <c:catAx>
        <c:axId val="6915324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91531464"/>
        <c:crossesAt val="0.1"/>
        <c:auto val="1"/>
        <c:lblAlgn val="ctr"/>
        <c:lblOffset val="100"/>
        <c:noMultiLvlLbl val="0"/>
      </c:catAx>
      <c:valAx>
        <c:axId val="691531464"/>
        <c:scaling>
          <c:logBase val="10"/>
          <c:orientation val="minMax"/>
          <c:min val="0.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91532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8CFBC4-5A80-4315-A249-480EA5C22C60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CD4431-CAC5-4639-B236-D63BD774E6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04651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CD4431-CAC5-4639-B236-D63BD774E690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925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FB30C-F89A-4F89-B2A5-9C529E1A953E}" type="datetimeFigureOut">
              <a:rPr lang="de-DE" smtClean="0"/>
              <a:t>15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70228-ECEF-467A-B6A1-0824017A8AEF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>
            <a:extLst>
              <a:ext uri="{FF2B5EF4-FFF2-40B4-BE49-F238E27FC236}">
                <a16:creationId xmlns:a16="http://schemas.microsoft.com/office/drawing/2014/main" id="{87BB7EA0-1378-4AE4-A657-DB17070D4E34}"/>
              </a:ext>
            </a:extLst>
          </p:cNvPr>
          <p:cNvSpPr/>
          <p:nvPr/>
        </p:nvSpPr>
        <p:spPr>
          <a:xfrm>
            <a:off x="683568" y="1052736"/>
            <a:ext cx="7128792" cy="56593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lustration for Introduction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heme of experimental approach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100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cript abundance of human DICER1 in various tissue of the body. Figures derived from human </a:t>
            </a:r>
            <a:r>
              <a:rPr lang="en-US" sz="10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P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rowser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lustration of Sampling, antibody status and SARS-CoV-2 derived small RNAs in patients (</a:t>
            </a:r>
            <a:r>
              <a:rPr lang="en-US" sz="1000" u="sng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ve/Severe COVID-19 (ICU): dark green, mild COVID-19: light green, recovered from COVID-19: turquoise, control samples (negative for presence of SARS-CoV-2 by PCR-test): grey bars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lustration of sampling * - detection of first symptoms, x – timepoint of death, line indicate the (first) sampling point, second line – second sampling point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amount of SARS-CoV-2 specific antibodies in patients’ blood. Green bar:  late NCP-IgG directed against the nucleocapsid protein (NCP), blue bar: early S1-IgA directed against the Spike protein (S1), violet bar: late S1-IgG directed against the Spike protein determined as relative titer by ELISA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RS-CoV-2 derived small RNAs: bars indicate the normalized reads per million [RPM]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tailed illustration of the small RNA clusters located at nsp2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100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position of the four 19 </a:t>
            </a:r>
            <a:r>
              <a:rPr lang="en-US" sz="10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ong sequences in the SARS-CoV-2 genome. Red arrows indicate position and orientation of reads. Numbers indicate the 5´start of the sequence. 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 of circ-</a:t>
            </a:r>
            <a:r>
              <a:rPr lang="en-US" sz="1000" u="sng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sa</a:t>
            </a: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miRNAs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nciple component analysis of mapped and normalized (</a:t>
            </a:r>
            <a:r>
              <a:rPr lang="en-US" sz="10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Seq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has-miRNAs. Severe COVID-19 (ICU): dark green, mild COVID-19: light green, recovered from COVID-19: blue, control samples (negative for presence of SARS-CoV-2 by PCR-test): grey dots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Volcano plot indicating differential abundant has-miRNAs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457200">
              <a:lnSpc>
                <a:spcPct val="115000"/>
              </a:lnSpc>
              <a:spcAft>
                <a:spcPts val="0"/>
              </a:spcAft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ue dots: p&lt;0.05 and log2 fold change &lt;-2 or &gt;2, others: red dots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457200"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BC99B5B2-8B80-494F-86CD-C77F7280683D}"/>
              </a:ext>
            </a:extLst>
          </p:cNvPr>
          <p:cNvSpPr txBox="1"/>
          <p:nvPr/>
        </p:nvSpPr>
        <p:spPr>
          <a:xfrm>
            <a:off x="683568" y="476672"/>
            <a:ext cx="2026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Legend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529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>
            <a:extLst>
              <a:ext uri="{FF2B5EF4-FFF2-40B4-BE49-F238E27FC236}">
                <a16:creationId xmlns:a16="http://schemas.microsoft.com/office/drawing/2014/main" id="{E268EA90-1D24-4C78-94FE-E05C9C21C16E}"/>
              </a:ext>
            </a:extLst>
          </p:cNvPr>
          <p:cNvSpPr/>
          <p:nvPr/>
        </p:nvSpPr>
        <p:spPr>
          <a:xfrm>
            <a:off x="755576" y="908720"/>
            <a:ext cx="7200800" cy="4628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lected </a:t>
            </a:r>
            <a:r>
              <a:rPr lang="en-US" sz="1000" u="sng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sa</a:t>
            </a: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miRNAs associated with inflammation response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undance of selected has-miRNAs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1000"/>
              </a:spcAft>
              <a:buFont typeface="+mj-lt"/>
              <a:buAutoNum type="alphaUcPeriod"/>
            </a:pP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sa-miR-LET7, B. has-miR-23b-5p and C. hsa-miR-19A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ve/Severe COVID-19 (ICU): dark green, mild COVID-19: light green, recovered from COVID-19: turquoise, control samples (negative for presence of SARS-CoV-2 by PCR-test): grey bars.</a:t>
            </a:r>
            <a:r>
              <a:rPr lang="en-US" sz="10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rs indicate the number of normalized reads per million [RPM].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RS-CoV-2 derived reads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s for summary, individual reads for severe, mild and control in sense and antisense, identified targets by </a:t>
            </a:r>
            <a:r>
              <a:rPr lang="en-US" sz="10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RNAtarget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read 1-4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2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u="sng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rc-miRNAs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s for all identified miRNAs, differential abundant miRNAs, tRNA, differential abundant tRNAs, ENST entries, differential abundant </a:t>
            </a:r>
            <a:r>
              <a:rPr lang="en-US" sz="10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ncRNAs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ummary, summary samples 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e-DE" sz="10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4015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9" name="Grafik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3479" y="3501008"/>
            <a:ext cx="3166639" cy="24482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40" name="Textfeld 3"/>
          <p:cNvSpPr txBox="1">
            <a:spLocks noChangeArrowheads="1"/>
          </p:cNvSpPr>
          <p:nvPr/>
        </p:nvSpPr>
        <p:spPr bwMode="auto">
          <a:xfrm>
            <a:off x="893999" y="3090446"/>
            <a:ext cx="237808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de-DE" altLang="de-DE" sz="1600" dirty="0"/>
              <a:t>Human DICER1 Expression</a:t>
            </a:r>
          </a:p>
        </p:txBody>
      </p:sp>
      <p:pic>
        <p:nvPicPr>
          <p:cNvPr id="5" name="Grafik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633838" y="3522022"/>
            <a:ext cx="3166640" cy="24272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feld 5"/>
          <p:cNvSpPr txBox="1"/>
          <p:nvPr/>
        </p:nvSpPr>
        <p:spPr>
          <a:xfrm>
            <a:off x="0" y="0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</a:t>
            </a:r>
            <a:r>
              <a:rPr lang="de-DE" dirty="0" err="1"/>
              <a:t>Figure</a:t>
            </a:r>
            <a:r>
              <a:rPr lang="de-DE" dirty="0"/>
              <a:t> 1</a:t>
            </a:r>
          </a:p>
          <a:p>
            <a:endParaRPr lang="de-DE" dirty="0"/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BC8F9D7B-6BC1-4CD8-9DC7-C440AAD16B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3528" y="402062"/>
            <a:ext cx="6264400" cy="2520280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4DF4D08F-4EBE-415F-90ED-077A8468E93B}"/>
              </a:ext>
            </a:extLst>
          </p:cNvPr>
          <p:cNvSpPr txBox="1"/>
          <p:nvPr/>
        </p:nvSpPr>
        <p:spPr>
          <a:xfrm>
            <a:off x="442106" y="30747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>
            <a:extLst>
              <a:ext uri="{FF2B5EF4-FFF2-40B4-BE49-F238E27FC236}">
                <a16:creationId xmlns:a16="http://schemas.microsoft.com/office/drawing/2014/main" id="{1F75E4A1-8AF1-440C-B445-3D719EF4E9FC}"/>
              </a:ext>
            </a:extLst>
          </p:cNvPr>
          <p:cNvSpPr/>
          <p:nvPr/>
        </p:nvSpPr>
        <p:spPr>
          <a:xfrm>
            <a:off x="179512" y="116632"/>
            <a:ext cx="16243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2 </a:t>
            </a:r>
          </a:p>
        </p:txBody>
      </p:sp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83F822C1-EEA5-4FB7-B991-0DD790FB63F3}"/>
              </a:ext>
            </a:extLst>
          </p:cNvPr>
          <p:cNvGrpSpPr/>
          <p:nvPr/>
        </p:nvGrpSpPr>
        <p:grpSpPr>
          <a:xfrm>
            <a:off x="331486" y="908720"/>
            <a:ext cx="8480255" cy="2880320"/>
            <a:chOff x="331486" y="908720"/>
            <a:chExt cx="8480255" cy="2880320"/>
          </a:xfrm>
        </p:grpSpPr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79204422-62FE-4525-BE7D-17A3959391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1486" y="908720"/>
              <a:ext cx="8480255" cy="2880320"/>
            </a:xfrm>
            <a:prstGeom prst="rect">
              <a:avLst/>
            </a:prstGeom>
          </p:spPr>
        </p:pic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9DF7DB2D-74A2-424A-803B-6FEE8C1C7A17}"/>
                </a:ext>
              </a:extLst>
            </p:cNvPr>
            <p:cNvSpPr txBox="1"/>
            <p:nvPr/>
          </p:nvSpPr>
          <p:spPr>
            <a:xfrm>
              <a:off x="7740352" y="2852936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dirty="0" err="1"/>
                <a:t>control</a:t>
              </a:r>
              <a:endParaRPr lang="de-DE" sz="1050" dirty="0"/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27018E43-06A5-4FE0-B2F3-4B6064B3FC85}"/>
                </a:ext>
              </a:extLst>
            </p:cNvPr>
            <p:cNvSpPr txBox="1"/>
            <p:nvPr/>
          </p:nvSpPr>
          <p:spPr>
            <a:xfrm>
              <a:off x="2675758" y="1737102"/>
              <a:ext cx="7441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2nd </a:t>
              </a:r>
              <a:r>
                <a:rPr lang="de-DE" sz="800" dirty="0" err="1"/>
                <a:t>sampling</a:t>
              </a:r>
              <a:endParaRPr lang="de-DE" sz="800" dirty="0"/>
            </a:p>
          </p:txBody>
        </p:sp>
        <p:cxnSp>
          <p:nvCxnSpPr>
            <p:cNvPr id="8" name="Gerader Verbinder 7">
              <a:extLst>
                <a:ext uri="{FF2B5EF4-FFF2-40B4-BE49-F238E27FC236}">
                  <a16:creationId xmlns:a16="http://schemas.microsoft.com/office/drawing/2014/main" id="{768460BF-0AEB-4E15-85B2-B03D8C97DEEA}"/>
                </a:ext>
              </a:extLst>
            </p:cNvPr>
            <p:cNvCxnSpPr>
              <a:cxnSpLocks/>
            </p:cNvCxnSpPr>
            <p:nvPr/>
          </p:nvCxnSpPr>
          <p:spPr>
            <a:xfrm>
              <a:off x="2699792" y="1772816"/>
              <a:ext cx="0" cy="14401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335E439D-35DC-4681-8499-543B97B40EEE}"/>
                </a:ext>
              </a:extLst>
            </p:cNvPr>
            <p:cNvSpPr txBox="1"/>
            <p:nvPr/>
          </p:nvSpPr>
          <p:spPr>
            <a:xfrm>
              <a:off x="2891782" y="2231866"/>
              <a:ext cx="7441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2nd </a:t>
              </a:r>
              <a:r>
                <a:rPr lang="de-DE" sz="800" dirty="0" err="1"/>
                <a:t>sampling</a:t>
              </a:r>
              <a:endParaRPr lang="de-DE" sz="800" dirty="0"/>
            </a:p>
          </p:txBody>
        </p:sp>
        <p:cxnSp>
          <p:nvCxnSpPr>
            <p:cNvPr id="11" name="Gerader Verbinder 10">
              <a:extLst>
                <a:ext uri="{FF2B5EF4-FFF2-40B4-BE49-F238E27FC236}">
                  <a16:creationId xmlns:a16="http://schemas.microsoft.com/office/drawing/2014/main" id="{E544E1D2-571D-4390-A070-67B39D694757}"/>
                </a:ext>
              </a:extLst>
            </p:cNvPr>
            <p:cNvCxnSpPr>
              <a:cxnSpLocks/>
            </p:cNvCxnSpPr>
            <p:nvPr/>
          </p:nvCxnSpPr>
          <p:spPr>
            <a:xfrm>
              <a:off x="2699792" y="2267580"/>
              <a:ext cx="0" cy="14401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Textfeld 8">
            <a:extLst>
              <a:ext uri="{FF2B5EF4-FFF2-40B4-BE49-F238E27FC236}">
                <a16:creationId xmlns:a16="http://schemas.microsoft.com/office/drawing/2014/main" id="{6F717880-C331-4823-AC5C-77E0CD80023B}"/>
              </a:ext>
            </a:extLst>
          </p:cNvPr>
          <p:cNvSpPr txBox="1"/>
          <p:nvPr/>
        </p:nvSpPr>
        <p:spPr>
          <a:xfrm>
            <a:off x="539552" y="911918"/>
            <a:ext cx="31771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AF0779F1-9E85-46A6-A5C8-C49BA4C85FD2}"/>
              </a:ext>
            </a:extLst>
          </p:cNvPr>
          <p:cNvSpPr txBox="1"/>
          <p:nvPr/>
        </p:nvSpPr>
        <p:spPr>
          <a:xfrm>
            <a:off x="4139952" y="908720"/>
            <a:ext cx="31771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ED07649E-851D-4271-8ADC-DA050C20C92B}"/>
              </a:ext>
            </a:extLst>
          </p:cNvPr>
          <p:cNvSpPr txBox="1"/>
          <p:nvPr/>
        </p:nvSpPr>
        <p:spPr>
          <a:xfrm>
            <a:off x="6372200" y="908720"/>
            <a:ext cx="31771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2E799925-B04E-4FF7-AF1A-49A3410815CF}"/>
              </a:ext>
            </a:extLst>
          </p:cNvPr>
          <p:cNvSpPr txBox="1"/>
          <p:nvPr/>
        </p:nvSpPr>
        <p:spPr>
          <a:xfrm>
            <a:off x="6665269" y="1026544"/>
            <a:ext cx="209704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RS-CoV-2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riv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mall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RNAs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A25FC810-01F2-433C-B817-C7BB727B53AF}"/>
              </a:ext>
            </a:extLst>
          </p:cNvPr>
          <p:cNvSpPr txBox="1"/>
          <p:nvPr/>
        </p:nvSpPr>
        <p:spPr>
          <a:xfrm>
            <a:off x="4571613" y="1026543"/>
            <a:ext cx="155363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RS-CoV-2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tibodies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70769354-6C5E-448F-A742-6C99B8F71F8C}"/>
              </a:ext>
            </a:extLst>
          </p:cNvPr>
          <p:cNvSpPr txBox="1"/>
          <p:nvPr/>
        </p:nvSpPr>
        <p:spPr>
          <a:xfrm>
            <a:off x="2195736" y="1035029"/>
            <a:ext cx="69602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ampling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0572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5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7" y="620688"/>
            <a:ext cx="6696744" cy="11990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feld 6"/>
          <p:cNvSpPr txBox="1">
            <a:spLocks noChangeArrowheads="1"/>
          </p:cNvSpPr>
          <p:nvPr/>
        </p:nvSpPr>
        <p:spPr bwMode="auto">
          <a:xfrm>
            <a:off x="727621" y="332656"/>
            <a:ext cx="13484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luster nsp2-1</a:t>
            </a:r>
          </a:p>
        </p:txBody>
      </p:sp>
      <p:sp>
        <p:nvSpPr>
          <p:cNvPr id="8" name="Textfeld 8"/>
          <p:cNvSpPr txBox="1">
            <a:spLocks noChangeArrowheads="1"/>
          </p:cNvSpPr>
          <p:nvPr/>
        </p:nvSpPr>
        <p:spPr bwMode="auto">
          <a:xfrm>
            <a:off x="4355976" y="1988840"/>
            <a:ext cx="260161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CTTCAATGGGGGATGTCC 19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10"/>
          <p:cNvSpPr txBox="1">
            <a:spLocks noChangeArrowheads="1"/>
          </p:cNvSpPr>
          <p:nvPr/>
        </p:nvSpPr>
        <p:spPr bwMode="auto">
          <a:xfrm>
            <a:off x="1945194" y="404664"/>
            <a:ext cx="24768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CCCTAAGAGGGGTGTAT 18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Grafik 4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8314" y="2220318"/>
            <a:ext cx="6623968" cy="2467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feld 11"/>
          <p:cNvSpPr txBox="1"/>
          <p:nvPr/>
        </p:nvSpPr>
        <p:spPr>
          <a:xfrm>
            <a:off x="0" y="-11145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2</a:t>
            </a:r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id="{B3D5C7AF-C8BA-4794-89FE-2CF1C6BAD2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3568" y="4706320"/>
            <a:ext cx="5834606" cy="1769309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47B7369C-3A57-4C03-8116-AEFD1C24CECC}"/>
              </a:ext>
            </a:extLst>
          </p:cNvPr>
          <p:cNvSpPr txBox="1"/>
          <p:nvPr/>
        </p:nvSpPr>
        <p:spPr>
          <a:xfrm>
            <a:off x="386692" y="460731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E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E429D660-1A8B-48D4-916E-5F0028270C4A}"/>
              </a:ext>
            </a:extLst>
          </p:cNvPr>
          <p:cNvSpPr txBox="1"/>
          <p:nvPr/>
        </p:nvSpPr>
        <p:spPr>
          <a:xfrm>
            <a:off x="306780" y="26064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  <p:sp>
        <p:nvSpPr>
          <p:cNvPr id="16" name="Textfeld 6">
            <a:extLst>
              <a:ext uri="{FF2B5EF4-FFF2-40B4-BE49-F238E27FC236}">
                <a16:creationId xmlns:a16="http://schemas.microsoft.com/office/drawing/2014/main" id="{844B2B52-D57E-4FE8-9E8A-68104F2706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5784" y="1969095"/>
            <a:ext cx="134844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luster nsp2-2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0" y="0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</a:t>
            </a:r>
            <a:r>
              <a:rPr lang="de-DE" dirty="0" err="1"/>
              <a:t>Figure</a:t>
            </a:r>
            <a:r>
              <a:rPr lang="de-DE" dirty="0"/>
              <a:t> 3</a:t>
            </a:r>
          </a:p>
          <a:p>
            <a:endParaRPr lang="de-DE" dirty="0"/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F443E4A0-416F-4ABA-B253-DDDA12B516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003" y="3991362"/>
            <a:ext cx="5196741" cy="2605990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1FB35820-6A44-4944-8329-A1046C935738}"/>
              </a:ext>
            </a:extLst>
          </p:cNvPr>
          <p:cNvSpPr txBox="1"/>
          <p:nvPr/>
        </p:nvSpPr>
        <p:spPr>
          <a:xfrm>
            <a:off x="611560" y="47667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E22D94F5-E30A-4632-AFA1-E131B2ADA03A}"/>
              </a:ext>
            </a:extLst>
          </p:cNvPr>
          <p:cNvSpPr txBox="1"/>
          <p:nvPr/>
        </p:nvSpPr>
        <p:spPr>
          <a:xfrm>
            <a:off x="611560" y="406778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grpSp>
        <p:nvGrpSpPr>
          <p:cNvPr id="8" name="Gruppieren 7">
            <a:extLst>
              <a:ext uri="{FF2B5EF4-FFF2-40B4-BE49-F238E27FC236}">
                <a16:creationId xmlns:a16="http://schemas.microsoft.com/office/drawing/2014/main" id="{2055B476-4781-444E-8FEA-AAEA43C152AF}"/>
              </a:ext>
            </a:extLst>
          </p:cNvPr>
          <p:cNvGrpSpPr/>
          <p:nvPr/>
        </p:nvGrpSpPr>
        <p:grpSpPr>
          <a:xfrm>
            <a:off x="1944216" y="374194"/>
            <a:ext cx="4587585" cy="3270830"/>
            <a:chOff x="1944216" y="374194"/>
            <a:chExt cx="4587585" cy="3270830"/>
          </a:xfrm>
        </p:grpSpPr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30877A71-EBFC-4992-95E5-390F6BBE0C8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44216" y="374194"/>
              <a:ext cx="4109009" cy="3270830"/>
            </a:xfrm>
            <a:prstGeom prst="rect">
              <a:avLst/>
            </a:prstGeom>
          </p:spPr>
        </p:pic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03C50DBF-392A-42DA-82E0-CA35454C7636}"/>
                </a:ext>
              </a:extLst>
            </p:cNvPr>
            <p:cNvSpPr txBox="1"/>
            <p:nvPr/>
          </p:nvSpPr>
          <p:spPr>
            <a:xfrm>
              <a:off x="5888676" y="1703161"/>
              <a:ext cx="643125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mild </a:t>
              </a:r>
            </a:p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ed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evere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Rechteck 3">
              <a:extLst>
                <a:ext uri="{FF2B5EF4-FFF2-40B4-BE49-F238E27FC236}">
                  <a16:creationId xmlns:a16="http://schemas.microsoft.com/office/drawing/2014/main" id="{0B70BA91-4A11-428D-838E-CE9C200A3B89}"/>
                </a:ext>
              </a:extLst>
            </p:cNvPr>
            <p:cNvSpPr/>
            <p:nvPr/>
          </p:nvSpPr>
          <p:spPr>
            <a:xfrm>
              <a:off x="5724128" y="1561104"/>
              <a:ext cx="329097" cy="1912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6" name="Textfeld 5">
            <a:extLst>
              <a:ext uri="{FF2B5EF4-FFF2-40B4-BE49-F238E27FC236}">
                <a16:creationId xmlns:a16="http://schemas.microsoft.com/office/drawing/2014/main" id="{4389B834-6B75-458C-BF35-B72A6942A5C3}"/>
              </a:ext>
            </a:extLst>
          </p:cNvPr>
          <p:cNvSpPr txBox="1"/>
          <p:nvPr/>
        </p:nvSpPr>
        <p:spPr>
          <a:xfrm>
            <a:off x="3779912" y="3852862"/>
            <a:ext cx="103701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olcan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Plot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</a:t>
            </a:r>
            <a:r>
              <a:rPr lang="de-DE" dirty="0" err="1"/>
              <a:t>Figure</a:t>
            </a:r>
            <a:r>
              <a:rPr lang="de-DE" dirty="0"/>
              <a:t> 4</a:t>
            </a:r>
          </a:p>
          <a:p>
            <a:endParaRPr lang="de-DE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90750" y="571500"/>
            <a:ext cx="4762500" cy="571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feld 5"/>
          <p:cNvSpPr txBox="1"/>
          <p:nvPr/>
        </p:nvSpPr>
        <p:spPr>
          <a:xfrm>
            <a:off x="0" y="6608385"/>
            <a:ext cx="27206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modifi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Neja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et al., 2018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6732240" y="1700808"/>
            <a:ext cx="1875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iR-19: 44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6732240" y="4653136"/>
            <a:ext cx="1875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iR-19; 44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6444208" y="1052736"/>
            <a:ext cx="17652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Let-7 F: 5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6804248" y="2348880"/>
            <a:ext cx="1875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iR-146: 3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6516216" y="3861048"/>
            <a:ext cx="2133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iR-23b-5p: 2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6660232" y="4941168"/>
            <a:ext cx="20249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iR-181: 1.8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251520" y="2276872"/>
            <a:ext cx="1875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iR-19: 44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186925" y="3356992"/>
            <a:ext cx="2133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iR-23b-5p: 2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467544" y="4365104"/>
            <a:ext cx="1875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miR-19: 44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own</a:t>
            </a:r>
          </a:p>
        </p:txBody>
      </p:sp>
      <p:sp>
        <p:nvSpPr>
          <p:cNvPr id="16" name="Sonne 15"/>
          <p:cNvSpPr/>
          <p:nvPr/>
        </p:nvSpPr>
        <p:spPr>
          <a:xfrm>
            <a:off x="4860032" y="548680"/>
            <a:ext cx="576064" cy="504056"/>
          </a:xfrm>
          <a:prstGeom prst="su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Sonne 16"/>
          <p:cNvSpPr/>
          <p:nvPr/>
        </p:nvSpPr>
        <p:spPr>
          <a:xfrm>
            <a:off x="3203848" y="836712"/>
            <a:ext cx="576064" cy="504056"/>
          </a:xfrm>
          <a:prstGeom prst="sun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25557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ure 5</a:t>
            </a:r>
          </a:p>
          <a:p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179512" y="54178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4716016" y="54868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179512" y="32241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465024" y="5572143"/>
            <a:ext cx="18501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orm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ad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RPM [log.]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585192" y="3212976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hsa-miR-19A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4BB12A34-F7F4-45C4-BFAD-DA10FD9635BB}"/>
              </a:ext>
            </a:extLst>
          </p:cNvPr>
          <p:cNvSpPr txBox="1"/>
          <p:nvPr/>
        </p:nvSpPr>
        <p:spPr>
          <a:xfrm>
            <a:off x="1428480" y="3002468"/>
            <a:ext cx="18501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orm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ad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RPM [log.]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C78DC005-FADE-4D3F-94BA-ADA3AD5630E6}"/>
              </a:ext>
            </a:extLst>
          </p:cNvPr>
          <p:cNvSpPr txBox="1"/>
          <p:nvPr/>
        </p:nvSpPr>
        <p:spPr>
          <a:xfrm>
            <a:off x="560419" y="534165"/>
            <a:ext cx="12682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hsa-miR-LET7F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183E26B7-C657-46D7-9D58-C7ABF5668ACE}"/>
              </a:ext>
            </a:extLst>
          </p:cNvPr>
          <p:cNvSpPr txBox="1"/>
          <p:nvPr/>
        </p:nvSpPr>
        <p:spPr>
          <a:xfrm>
            <a:off x="5115358" y="549913"/>
            <a:ext cx="12827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hsa-miR-23b-5p</a:t>
            </a:r>
          </a:p>
        </p:txBody>
      </p:sp>
      <p:graphicFrame>
        <p:nvGraphicFramePr>
          <p:cNvPr id="27" name="Diagramm 26">
            <a:extLst>
              <a:ext uri="{FF2B5EF4-FFF2-40B4-BE49-F238E27FC236}">
                <a16:creationId xmlns:a16="http://schemas.microsoft.com/office/drawing/2014/main" id="{3A46A341-BB6A-4412-A4D6-BCCE41C4DE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6988806"/>
              </p:ext>
            </p:extLst>
          </p:nvPr>
        </p:nvGraphicFramePr>
        <p:xfrm>
          <a:off x="179513" y="3467361"/>
          <a:ext cx="4049766" cy="21938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Diagramm 27">
            <a:extLst>
              <a:ext uri="{FF2B5EF4-FFF2-40B4-BE49-F238E27FC236}">
                <a16:creationId xmlns:a16="http://schemas.microsoft.com/office/drawing/2014/main" id="{68446566-BA18-44FA-85A9-93A2D67482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5878992"/>
              </p:ext>
            </p:extLst>
          </p:nvPr>
        </p:nvGraphicFramePr>
        <p:xfrm>
          <a:off x="152582" y="704730"/>
          <a:ext cx="4076696" cy="24362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0" name="Diagramm 29">
            <a:extLst>
              <a:ext uri="{FF2B5EF4-FFF2-40B4-BE49-F238E27FC236}">
                <a16:creationId xmlns:a16="http://schemas.microsoft.com/office/drawing/2014/main" id="{A29FF6D0-28BC-4A26-BE4A-FA304EC383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0924271"/>
              </p:ext>
            </p:extLst>
          </p:nvPr>
        </p:nvGraphicFramePr>
        <p:xfrm>
          <a:off x="4532451" y="850256"/>
          <a:ext cx="4026357" cy="2290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Textfeld 13">
            <a:extLst>
              <a:ext uri="{FF2B5EF4-FFF2-40B4-BE49-F238E27FC236}">
                <a16:creationId xmlns:a16="http://schemas.microsoft.com/office/drawing/2014/main" id="{E8F8398D-09F6-455F-8B1B-054F05144B60}"/>
              </a:ext>
            </a:extLst>
          </p:cNvPr>
          <p:cNvSpPr txBox="1"/>
          <p:nvPr/>
        </p:nvSpPr>
        <p:spPr>
          <a:xfrm>
            <a:off x="5868144" y="3018500"/>
            <a:ext cx="18501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Norm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ad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RPM [log.]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4</Words>
  <Application>Microsoft Office PowerPoint</Application>
  <PresentationFormat>Bildschirmpräsentation (4:3)</PresentationFormat>
  <Paragraphs>82</Paragraphs>
  <Slides>8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Larissa-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nutzer</dc:creator>
  <cp:lastModifiedBy>Markus Kuhlmann</cp:lastModifiedBy>
  <cp:revision>21</cp:revision>
  <dcterms:created xsi:type="dcterms:W3CDTF">2021-02-22T12:29:50Z</dcterms:created>
  <dcterms:modified xsi:type="dcterms:W3CDTF">2021-06-15T13:28:38Z</dcterms:modified>
</cp:coreProperties>
</file>